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60A4B4-13FD-F414-3AB8-C655D9F40A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0B42E0-3EE0-A157-19E9-3B3DD937A8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F4FD32-F196-5971-2407-6AC56BA83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C0632C-B5D5-DF3B-688B-C6BACF369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8BE44-1C7C-1298-9079-12E9AA89B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731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C50D4-5504-FBF5-54AF-3948DA25B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DA1889-CF28-569E-E405-9CA2AC08F6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5CBEBB-AB14-8757-817D-1D6ECECE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91EF47-3A0E-D728-A50F-3C1F6A7895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2B5A9-02DB-7C4D-7E63-2523E26BF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204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E043EF-3663-1A2A-0A83-F76D96B288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A73FCC-ADD4-1E53-027A-B330A18A29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507BB-1BA4-BA01-6BC1-092222F82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CE773-5CCF-EE09-1841-953113655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A5638C-4225-3BD9-9FA4-13EC344D2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088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8823DA-8508-2759-42FA-09B44DDFD0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9715DB-8C2B-A781-9C98-597358C3BC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6659B2-6AF2-B2AB-5FB5-11941BD64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21BF3D-94D8-F6DA-E18C-52AFBC493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E210C4-9E6E-210B-EE70-620F63815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699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014963-5431-55D9-7881-C850735CD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E8C531-ED26-61CD-F386-423A134DE9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4F014-5879-B9CE-7687-3BD96E46F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869A9E-B6CD-C8EE-E5B6-1676D360E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E46EF8-C52C-F3E0-F6F1-A237CEED4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67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CB425D-FB6B-394D-57FA-FB05C13E3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3CA8A-980B-3B1F-5585-8565FE01A6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D907C1-335E-D60F-82F6-810D68226C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7A206A-AA1F-2E0F-4916-2EF06B72D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9A3254-1B67-22BC-6F46-DF9473C87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FF88E4-E374-78D3-3A33-56CFA07E4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89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3A33BE-A0F2-31B8-E155-E9ADE111D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995CC2-1972-1A19-CF1D-9E4D8F105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F87543-04D7-7B33-1F8F-A5564B42A5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2B8EBC-F1EE-3FAD-2C07-8AAF116BD3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7E677A0-09F2-D7AC-F7B9-3C5324BE85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D23EA5-6254-A438-9642-D77A38C4F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1E077A-CCD7-BC8F-0B9D-7518D0EC7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5633F1-A34C-FA03-B5C0-C7E1F8CC3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20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D2ADD-AB7E-A4DD-4143-6606C70442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8D7B88-19CE-25D2-04F9-5EE69B51E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C46832-0DB3-4825-7B7B-50F99AE06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9A3945-6F50-3779-1C29-A5286E83F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185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677B45-C226-3C4C-437F-705F94086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690413-C1D2-3310-22F8-3E8822FDE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F24A48-CC40-342D-9B8F-875B37509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355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474FD7-2D04-BDC0-44A0-88E09EFC1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8A412F-7AFC-F64E-6CC9-9420644062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6A263D-0BD3-DE76-C49D-035F7A945A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72A9B4-8135-B68C-660D-10BDA9EDE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1434B2-4DE4-DD09-C02F-E841AC269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646FC6-0E82-959C-B9F9-52BC69FEF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424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C355E-6C77-F2F4-C350-B863E41CE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8082C7-90C6-8E88-BBCA-C54D1A38FB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2E6711-37C2-C073-B823-1DE3B4A828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D0DC33-7BB8-5F0E-9922-0780FA1CE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02A564-4B03-6D59-F121-08FC63394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101C7C-1E10-1D0F-7D05-1B2C0296E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611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63C5C5-3162-B7C0-80DA-B9822DBD7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D7D7F9-807F-D417-0E9C-E7D08C1CC6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7FECF9-5D35-A06A-DCA4-C6B0853846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E44EC-FD86-4907-9789-69C0179D255C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376A57-EF53-6955-5BF6-850E06D4CF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26B0ED-7BCA-3337-5475-D6C27E194A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DBF58C-ED35-40A5-B959-9B585CF3D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094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B0EEC3B-84B0-47CF-BDA2-77D5BADE4AC3}"/>
              </a:ext>
            </a:extLst>
          </p:cNvPr>
          <p:cNvSpPr txBox="1"/>
          <p:nvPr/>
        </p:nvSpPr>
        <p:spPr>
          <a:xfrm>
            <a:off x="412805" y="3832529"/>
            <a:ext cx="1067860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6. ZL-2201 reduces DNA damage-induced MCM2 phosphorylation (Ser108). </a:t>
            </a:r>
            <a:r>
              <a:rPr lang="en-US" sz="1600" dirty="0"/>
              <a:t>(A) A549 and (B) </a:t>
            </a:r>
            <a:r>
              <a:rPr lang="en-US" sz="1600" dirty="0" err="1"/>
              <a:t>FaDu</a:t>
            </a:r>
            <a:r>
              <a:rPr lang="en-US" sz="1600" dirty="0"/>
              <a:t> cells were pre-treated with 10um Bleomycin for 2 hours followed by ZL-2201 treatment at the indicated concentrations for 2 hours. Immunoblotting for p-DNAPK ( S2056), P-MCM2(S108) and loading control GAPDH was performed using Simple Western system.</a:t>
            </a:r>
            <a:r>
              <a:rPr lang="en-US" sz="1600" b="1" dirty="0"/>
              <a:t> </a:t>
            </a:r>
            <a:endParaRPr lang="en-US" sz="1600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C7E633D-2CA9-EA50-0291-D005E596E2EF}"/>
              </a:ext>
            </a:extLst>
          </p:cNvPr>
          <p:cNvGrpSpPr/>
          <p:nvPr/>
        </p:nvGrpSpPr>
        <p:grpSpPr>
          <a:xfrm>
            <a:off x="412805" y="722609"/>
            <a:ext cx="9441908" cy="2706391"/>
            <a:chOff x="348792" y="235670"/>
            <a:chExt cx="9441908" cy="2706391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46583E5-F167-5593-B3A5-062DD457B898}"/>
                </a:ext>
              </a:extLst>
            </p:cNvPr>
            <p:cNvSpPr txBox="1"/>
            <p:nvPr/>
          </p:nvSpPr>
          <p:spPr>
            <a:xfrm>
              <a:off x="348792" y="23567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94D3F8D-A4BC-AE77-3AC4-F9ED57475559}"/>
                </a:ext>
              </a:extLst>
            </p:cNvPr>
            <p:cNvSpPr txBox="1"/>
            <p:nvPr/>
          </p:nvSpPr>
          <p:spPr>
            <a:xfrm>
              <a:off x="5260157" y="23567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FF4BD3D-C04F-EAFC-C588-B2F066F55E9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9207" y="314457"/>
              <a:ext cx="4273666" cy="262760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80A39AE-CF78-578F-071F-8B1D56B4BA0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17034" y="307895"/>
              <a:ext cx="4273666" cy="262760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05981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Bhola</dc:creator>
  <cp:lastModifiedBy>Neil Bhola</cp:lastModifiedBy>
  <cp:revision>1</cp:revision>
  <dcterms:created xsi:type="dcterms:W3CDTF">2023-07-28T20:46:47Z</dcterms:created>
  <dcterms:modified xsi:type="dcterms:W3CDTF">2023-07-28T20:52:15Z</dcterms:modified>
</cp:coreProperties>
</file>